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76BFA7-369B-4EEF-A139-8523B111F44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818D02-FE89-4142-AB9D-06ECB74514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8D0AD3-CFF4-4442-B6BA-43B8304C10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7303B-67D0-473B-9E84-D39D859BAB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0DFE2-A76F-4082-A2BB-F78D96E910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B10B1A-098B-4E81-A5BA-4FEDF5F095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C7DDCB-8D67-4859-B2B0-0DABFB1317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78A479-A9C6-4CB0-9663-373F16E9C1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FB62AF-060F-4A54-9353-5EA4B86E80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5F168-EF0D-47A3-B428-78FAF4823D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0A053B-91A5-4A5D-8629-110C1DC78B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A6367-CA2B-4C5E-8519-151933C358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0632D8-D705-43BB-8FCD-4244E79FC5E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kiss1"/>
          <p:cNvPicPr/>
          <p:nvPr/>
        </p:nvPicPr>
        <p:blipFill>
          <a:blip r:embed="rId1"/>
          <a:srcRect l="11787" t="3791" r="24657" b="4408"/>
          <a:stretch/>
        </p:blipFill>
        <p:spPr>
          <a:xfrm>
            <a:off x="2732040" y="41400"/>
            <a:ext cx="2992320" cy="4321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kiss2"/>
          <p:cNvPicPr/>
          <p:nvPr/>
        </p:nvPicPr>
        <p:blipFill>
          <a:blip r:embed="rId2"/>
          <a:srcRect l="12929" t="6179" r="30573" b="0"/>
          <a:stretch/>
        </p:blipFill>
        <p:spPr>
          <a:xfrm>
            <a:off x="111240" y="41400"/>
            <a:ext cx="2660400" cy="44179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kiss3"/>
          <p:cNvPicPr/>
          <p:nvPr/>
        </p:nvPicPr>
        <p:blipFill>
          <a:blip r:embed="rId3"/>
          <a:srcRect l="19982" t="25896" r="11727" b="5869"/>
          <a:stretch/>
        </p:blipFill>
        <p:spPr>
          <a:xfrm>
            <a:off x="5796000" y="977760"/>
            <a:ext cx="3216240" cy="3214800"/>
          </a:xfrm>
          <a:prstGeom prst="rect">
            <a:avLst/>
          </a:prstGeom>
          <a:ln w="0">
            <a:noFill/>
          </a:ln>
        </p:spPr>
      </p:pic>
      <p:sp>
        <p:nvSpPr>
          <p:cNvPr id="44" name="ZoneTexte 5"/>
          <p:cNvSpPr/>
          <p:nvPr/>
        </p:nvSpPr>
        <p:spPr>
          <a:xfrm>
            <a:off x="250920" y="4387680"/>
            <a:ext cx="8642160" cy="1310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igure S2.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uman KISS1R tridimensional mode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Panel A: Tyr313, located in the middle of 7th transmembrane segment, is pointing at the hydrophobic  core.</a:t>
            </a:r>
            <a:r>
              <a:rPr b="0" lang="fr-FR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The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hydroxyl group of the tyrosine residue may form 2 hydrogen bonds with Cys95 and Thr99 both located in the 2</a:t>
            </a:r>
            <a:r>
              <a:rPr b="0" lang="en-US" sz="1600" spc="-1" strike="noStrike" baseline="30000">
                <a:solidFill>
                  <a:srgbClr val="000000"/>
                </a:solidFill>
                <a:latin typeface="Calibri"/>
                <a:ea typeface="ＭＳ Ｐゴシック"/>
              </a:rPr>
              <a:t>nd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transmembrane segment and stabilize cohesion of transmembrane bundle. These residues may participate in the docking of kisspeptin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ZoneTexte 403"/>
          <p:cNvSpPr/>
          <p:nvPr/>
        </p:nvSpPr>
        <p:spPr>
          <a:xfrm>
            <a:off x="7560360" y="189000"/>
            <a:ext cx="1180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S2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8"/>
          <p:cNvSpPr/>
          <p:nvPr/>
        </p:nvSpPr>
        <p:spPr>
          <a:xfrm>
            <a:off x="181440" y="11592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4" descr="kiss_mutated"/>
          <p:cNvPicPr/>
          <p:nvPr/>
        </p:nvPicPr>
        <p:blipFill>
          <a:blip r:embed="rId1"/>
          <a:stretch/>
        </p:blipFill>
        <p:spPr>
          <a:xfrm>
            <a:off x="4951440" y="657360"/>
            <a:ext cx="3058920" cy="30589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5" descr="kiss4"/>
          <p:cNvPicPr/>
          <p:nvPr/>
        </p:nvPicPr>
        <p:blipFill>
          <a:blip r:embed="rId2"/>
          <a:stretch/>
        </p:blipFill>
        <p:spPr>
          <a:xfrm>
            <a:off x="990720" y="657360"/>
            <a:ext cx="3058920" cy="3058920"/>
          </a:xfrm>
          <a:prstGeom prst="rect">
            <a:avLst/>
          </a:prstGeom>
          <a:ln w="0">
            <a:noFill/>
          </a:ln>
        </p:spPr>
      </p:pic>
      <p:sp>
        <p:nvSpPr>
          <p:cNvPr id="49" name="ZoneTexte 5"/>
          <p:cNvSpPr/>
          <p:nvPr/>
        </p:nvSpPr>
        <p:spPr>
          <a:xfrm>
            <a:off x="428760" y="4194000"/>
            <a:ext cx="835812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Figure S2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, Panel B : Focus on the mutated amino-acid residue : on the left, hydroxyl group of Tyr313 residue probably make hydrogenic bond with Cys95 (2.75 Å) and Thr99 (2.62 Å)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(Normal Hydrogenic bond range is 2.7 to 3.2 Å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On the right: Imidazole group of histidine mutant residue in position 313 is not able to form hydrogen bond with Cys 95 and Threonine 99 both located in the 2</a:t>
            </a:r>
            <a:r>
              <a:rPr b="0" lang="en-US" sz="1800" spc="-1" strike="noStrike" baseline="30000">
                <a:solidFill>
                  <a:srgbClr val="000000"/>
                </a:solidFill>
                <a:latin typeface="Calibri"/>
                <a:ea typeface="ＭＳ Ｐゴシック"/>
              </a:rPr>
              <a:t>nd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transmembrane segment and therefore impair cohesion of transmembrane bundl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7"/>
          <p:cNvSpPr/>
          <p:nvPr/>
        </p:nvSpPr>
        <p:spPr>
          <a:xfrm>
            <a:off x="253080" y="27936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ZoneTexte 1"/>
          <p:cNvSpPr/>
          <p:nvPr/>
        </p:nvSpPr>
        <p:spPr>
          <a:xfrm>
            <a:off x="7893000" y="44280"/>
            <a:ext cx="124596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2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S2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1T16:18:40Z</dcterms:created>
  <dc:creator> Anne Mantel</dc:creator>
  <dc:description/>
  <dc:language>en-US</dc:language>
  <cp:lastModifiedBy> Anne Mantel</cp:lastModifiedBy>
  <dcterms:modified xsi:type="dcterms:W3CDTF">2012-12-11T16:19:09Z</dcterms:modified>
  <cp:revision>1</cp:revision>
  <dc:subject/>
  <dc:title>Diapositive 1</dc:title>
</cp:coreProperties>
</file>